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312" r:id="rId2"/>
  </p:sldIdLst>
  <p:sldSz cx="6858000" cy="7315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480" userDrawn="1">
          <p15:clr>
            <a:srgbClr val="A4A3A4"/>
          </p15:clr>
        </p15:guide>
        <p15:guide id="3" pos="2304" userDrawn="1">
          <p15:clr>
            <a:srgbClr val="A4A3A4"/>
          </p15:clr>
        </p15:guide>
        <p15:guide id="4" orient="horz" pos="23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115"/>
    <p:restoredTop sz="96000"/>
  </p:normalViewPr>
  <p:slideViewPr>
    <p:cSldViewPr snapToGrid="0" snapToObjects="1" showGuides="1">
      <p:cViewPr varScale="1">
        <p:scale>
          <a:sx n="110" d="100"/>
          <a:sy n="110" d="100"/>
        </p:scale>
        <p:origin x="1584" y="168"/>
      </p:cViewPr>
      <p:guideLst>
        <p:guide pos="480"/>
        <p:guide pos="2304"/>
        <p:guide orient="horz" pos="23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6CECC3-DD5D-A941-8C9E-667403EEA2C7}" type="datetimeFigureOut">
              <a:rPr lang="en-US" smtClean="0"/>
              <a:t>1/16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1143000"/>
            <a:ext cx="2892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C27914-89CC-AF4D-AD01-D1AAC30E2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128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Shape 187"/>
          <p:cNvSpPr>
            <a:spLocks noGrp="1" noRot="1" noChangeAspect="1"/>
          </p:cNvSpPr>
          <p:nvPr>
            <p:ph type="sldImg"/>
          </p:nvPr>
        </p:nvSpPr>
        <p:spPr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88" name="Shape 188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sz="1200" b="1" kern="120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1. Inflammatory mRNA relative gene expressions of the lung homogenates. 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l1b, Il6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al time PCR is performed to compare mRNA gene expression.  A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l1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is upregulated after CA in the lung, which is significantly attenuated by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ormoxi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therapy. B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l6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is upregulated after CA in the lung, which is significantly attenuated by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ormoxi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therapy. N = 6. **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 &lt;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01, ***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&lt; 0.001 t-test. </a:t>
            </a:r>
          </a:p>
        </p:txBody>
      </p:sp>
    </p:spTree>
    <p:extLst>
      <p:ext uri="{BB962C8B-B14F-4D97-AF65-F5344CB8AC3E}">
        <p14:creationId xmlns:p14="http://schemas.microsoft.com/office/powerpoint/2010/main" val="27615205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197187"/>
            <a:ext cx="5829300" cy="254677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842174"/>
            <a:ext cx="5143500" cy="176614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110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406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89467"/>
            <a:ext cx="1478756" cy="61992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89467"/>
            <a:ext cx="4350544" cy="619929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7568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700615825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234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823722"/>
            <a:ext cx="5915025" cy="304291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895429"/>
            <a:ext cx="5915025" cy="16001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691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947333"/>
            <a:ext cx="2914650" cy="46414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947333"/>
            <a:ext cx="2914650" cy="46414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313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89468"/>
            <a:ext cx="5915025" cy="14139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793241"/>
            <a:ext cx="2901255" cy="87883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672080"/>
            <a:ext cx="2901255" cy="39302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793241"/>
            <a:ext cx="2915543" cy="87883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672080"/>
            <a:ext cx="2915543" cy="39302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93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000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545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7680"/>
            <a:ext cx="2211884" cy="17068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053255"/>
            <a:ext cx="3471863" cy="519853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194560"/>
            <a:ext cx="2211884" cy="406569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135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7680"/>
            <a:ext cx="2211884" cy="17068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053255"/>
            <a:ext cx="3471863" cy="5198533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194560"/>
            <a:ext cx="2211884" cy="406569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972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89468"/>
            <a:ext cx="5915025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947333"/>
            <a:ext cx="5915025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6780108"/>
            <a:ext cx="154305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91C62-FB98-3642-81E8-5962FB001C79}" type="datetimeFigureOut">
              <a:rPr lang="en-US" smtClean="0"/>
              <a:t>1/1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6780108"/>
            <a:ext cx="2314575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6780108"/>
            <a:ext cx="154305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E20B13-9315-434D-9BA7-D5221A18A3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605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  <p:sldLayoutId id="2147483720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F6BD4B1-C10A-164F-7CC1-254A2EBF66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0440" y="91440"/>
            <a:ext cx="2685143" cy="45720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8B55A95E-5461-DA9D-AEF9-7D47DD4D5E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1481" y="91440"/>
            <a:ext cx="2560735" cy="4572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0002148-43E6-F242-AB2E-CF0958A8A102}"/>
              </a:ext>
            </a:extLst>
          </p:cNvPr>
          <p:cNvSpPr txBox="1"/>
          <p:nvPr/>
        </p:nvSpPr>
        <p:spPr>
          <a:xfrm>
            <a:off x="44651" y="4572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8DFA1D0-AD08-6745-A254-C640EFF899DF}"/>
              </a:ext>
            </a:extLst>
          </p:cNvPr>
          <p:cNvSpPr txBox="1"/>
          <p:nvPr/>
        </p:nvSpPr>
        <p:spPr>
          <a:xfrm>
            <a:off x="3153611" y="4572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55F695C-0BCF-66B4-5347-9A8988FE89E1}"/>
              </a:ext>
            </a:extLst>
          </p:cNvPr>
          <p:cNvSpPr txBox="1"/>
          <p:nvPr/>
        </p:nvSpPr>
        <p:spPr>
          <a:xfrm>
            <a:off x="81592" y="4663440"/>
            <a:ext cx="669481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Inflammatory mRNA relative gene expressions of the lung homogenates. 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l1b, Il6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al time PCR is performed to compare mRNA gene expression.  A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l1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s upregulated after CA in the lung, which is significantly attenuated by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rmoxi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rapy. B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l6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s upregulated after CA in the lung, which is significantly attenuated by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rmoxi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rapy. N = 6. **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&lt;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1, ***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&lt; 0.001 t-test. </a:t>
            </a:r>
          </a:p>
        </p:txBody>
      </p:sp>
    </p:spTree>
    <p:extLst>
      <p:ext uri="{BB962C8B-B14F-4D97-AF65-F5344CB8AC3E}">
        <p14:creationId xmlns:p14="http://schemas.microsoft.com/office/powerpoint/2010/main" val="3792262764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256</TotalTime>
  <Words>164</Words>
  <Application>Microsoft Macintosh PowerPoint</Application>
  <PresentationFormat>Custom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nozaki, Koichiro</dc:creator>
  <cp:lastModifiedBy>丈明 青木</cp:lastModifiedBy>
  <cp:revision>131</cp:revision>
  <dcterms:created xsi:type="dcterms:W3CDTF">2020-04-13T04:00:57Z</dcterms:created>
  <dcterms:modified xsi:type="dcterms:W3CDTF">2023-01-16T22:57:38Z</dcterms:modified>
</cp:coreProperties>
</file>